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5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300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10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839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95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893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433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52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663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71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704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4B1A6-1B0B-48B2-84C2-90704B2CCF3C}" type="datetimeFigureOut">
              <a:rPr lang="en-US" smtClean="0"/>
              <a:t>4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D97D6-0DE0-40E8-8A5A-E92CE023A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87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4.emf"/><Relationship Id="rId7" Type="http://schemas.microsoft.com/office/2007/relationships/hdphoto" Target="../media/hdphoto1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em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FB6A46A-5E12-67B6-FA4D-BE50FE52A9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101" y="4909384"/>
            <a:ext cx="2783888" cy="230981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9F846A0-E8B2-B520-9256-20634A66E7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832" y="7714737"/>
            <a:ext cx="2777844" cy="2309812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FA6D95A-E7B5-5481-C06F-8E30EF889E06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bright="15000" contrast="-1000"/>
          </a:blip>
          <a:stretch>
            <a:fillRect/>
          </a:stretch>
        </p:blipFill>
        <p:spPr>
          <a:xfrm>
            <a:off x="3429000" y="2220641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38B7F8-31EE-ED6B-6CCB-5DBF1B4B6C90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12000" contrast="5000"/>
          </a:blip>
          <a:stretch>
            <a:fillRect/>
          </a:stretch>
        </p:blipFill>
        <p:spPr>
          <a:xfrm>
            <a:off x="3429000" y="4894099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168E213-CB94-3909-26D2-70E4C37CB454}"/>
              </a:ext>
            </a:extLst>
          </p:cNvPr>
          <p:cNvPicPr>
            <a:picLocks noChangeAspect="1"/>
          </p:cNvPicPr>
          <p:nvPr/>
        </p:nvPicPr>
        <p:blipFill>
          <a:blip r:embed="rId6">
            <a:lum bright="20000" contrast="-2000"/>
          </a:blip>
          <a:stretch>
            <a:fillRect/>
          </a:stretch>
        </p:blipFill>
        <p:spPr>
          <a:xfrm>
            <a:off x="3420731" y="7718527"/>
            <a:ext cx="2777844" cy="2313432"/>
          </a:xfrm>
          <a:prstGeom prst="rect">
            <a:avLst/>
          </a:prstGeom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BADBF59-32DA-FAE6-D5E0-D670D76D93CA}"/>
              </a:ext>
            </a:extLst>
          </p:cNvPr>
          <p:cNvSpPr txBox="1"/>
          <p:nvPr/>
        </p:nvSpPr>
        <p:spPr>
          <a:xfrm>
            <a:off x="1448881" y="693174"/>
            <a:ext cx="4250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ource data-DA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0- 1 to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E3D165-427B-EA6F-EE9A-7E4966CA1F34}"/>
              </a:ext>
            </a:extLst>
          </p:cNvPr>
          <p:cNvSpPr txBox="1"/>
          <p:nvPr/>
        </p:nvSpPr>
        <p:spPr>
          <a:xfrm>
            <a:off x="224684" y="1499612"/>
            <a:ext cx="277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tamin A autofluorescen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ADAA2E-64B2-E2F8-10FC-714FD3857119}"/>
              </a:ext>
            </a:extLst>
          </p:cNvPr>
          <p:cNvSpPr txBox="1"/>
          <p:nvPr/>
        </p:nvSpPr>
        <p:spPr>
          <a:xfrm>
            <a:off x="4403394" y="1459558"/>
            <a:ext cx="1161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ightfiel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FE3AAAA-FCC3-50AB-CFEE-6CDFD75AC3E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832" y="2149162"/>
            <a:ext cx="2786113" cy="2310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52572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9167306-5217-15F7-4C70-9FE67A3076F9}"/>
              </a:ext>
            </a:extLst>
          </p:cNvPr>
          <p:cNvSpPr txBox="1"/>
          <p:nvPr/>
        </p:nvSpPr>
        <p:spPr>
          <a:xfrm>
            <a:off x="1448881" y="693174"/>
            <a:ext cx="4250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 source data-DAY 5- 1 to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B0781D1-B09A-A1FA-5D70-4C2DE7DCBA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862" y="2632629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BAFC499-46E7-0318-9428-4098C3FF6D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862" y="5085400"/>
            <a:ext cx="2780006" cy="230981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FCEB973-5C37-E2C4-C2AE-A915C70E3D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4862" y="7509946"/>
            <a:ext cx="2781300" cy="2309812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B3804AD-757D-AD4E-BD81-41D64B7AFD31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13000" contrast="3000"/>
          </a:blip>
          <a:stretch>
            <a:fillRect/>
          </a:stretch>
        </p:blipFill>
        <p:spPr>
          <a:xfrm>
            <a:off x="3581610" y="2632629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8CB18EA-66B3-6E3A-383D-C9F6FA39E813}"/>
              </a:ext>
            </a:extLst>
          </p:cNvPr>
          <p:cNvPicPr>
            <a:picLocks noChangeAspect="1"/>
          </p:cNvPicPr>
          <p:nvPr/>
        </p:nvPicPr>
        <p:blipFill>
          <a:blip r:embed="rId6">
            <a:lum bright="17000" contrast="4000"/>
          </a:blip>
          <a:stretch>
            <a:fillRect/>
          </a:stretch>
        </p:blipFill>
        <p:spPr>
          <a:xfrm>
            <a:off x="3581610" y="5070115"/>
            <a:ext cx="2746405" cy="2313432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B15047C-BAC5-A74B-22F6-4240EF6D73A6}"/>
              </a:ext>
            </a:extLst>
          </p:cNvPr>
          <p:cNvPicPr>
            <a:picLocks noChangeAspect="1"/>
          </p:cNvPicPr>
          <p:nvPr/>
        </p:nvPicPr>
        <p:blipFill>
          <a:blip r:embed="rId7">
            <a:lum bright="19000" contrast="-6000"/>
          </a:blip>
          <a:stretch>
            <a:fillRect/>
          </a:stretch>
        </p:blipFill>
        <p:spPr>
          <a:xfrm>
            <a:off x="3581610" y="7513736"/>
            <a:ext cx="2740708" cy="2313432"/>
          </a:xfrm>
          <a:prstGeom prst="rect">
            <a:avLst/>
          </a:prstGeom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F6D968-8566-94AD-434C-FF61546AED22}"/>
              </a:ext>
            </a:extLst>
          </p:cNvPr>
          <p:cNvSpPr txBox="1"/>
          <p:nvPr/>
        </p:nvSpPr>
        <p:spPr>
          <a:xfrm>
            <a:off x="284445" y="1772318"/>
            <a:ext cx="277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tamin A autofluoresce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488527-BF3C-2ADB-53CE-D9C5D29D140F}"/>
              </a:ext>
            </a:extLst>
          </p:cNvPr>
          <p:cNvSpPr txBox="1"/>
          <p:nvPr/>
        </p:nvSpPr>
        <p:spPr>
          <a:xfrm>
            <a:off x="4463155" y="1732264"/>
            <a:ext cx="1161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ightfield</a:t>
            </a:r>
          </a:p>
        </p:txBody>
      </p:sp>
    </p:spTree>
    <p:extLst>
      <p:ext uri="{BB962C8B-B14F-4D97-AF65-F5344CB8AC3E}">
        <p14:creationId xmlns:p14="http://schemas.microsoft.com/office/powerpoint/2010/main" val="6990894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E295832-AEB3-AC72-27F9-6A252C123D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687" y="2351590"/>
            <a:ext cx="2777844" cy="2314226"/>
          </a:xfrm>
          <a:prstGeom prst="rect">
            <a:avLst/>
          </a:prstGeom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1C7A6AC-298E-3B19-7FBE-12D6B5CB3343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6000" contrast="13000"/>
          </a:blip>
          <a:stretch>
            <a:fillRect/>
          </a:stretch>
        </p:blipFill>
        <p:spPr>
          <a:xfrm>
            <a:off x="3739820" y="2351590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8FFD722-F15C-9FC2-3860-B37CA703A6AB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bright="11000" contrast="29000"/>
          </a:blip>
          <a:stretch>
            <a:fillRect/>
          </a:stretch>
        </p:blipFill>
        <p:spPr>
          <a:xfrm>
            <a:off x="3739820" y="4789076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CD07B7C-F7FA-1EC5-CF11-EF401F4A5336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12000" contrast="39000"/>
          </a:blip>
          <a:stretch>
            <a:fillRect/>
          </a:stretch>
        </p:blipFill>
        <p:spPr>
          <a:xfrm>
            <a:off x="3739820" y="7232697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CA87416-1575-B186-C3F0-7E889F1D0CC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9687" y="4789076"/>
            <a:ext cx="2777844" cy="231422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7D7458-1358-DE8F-A398-F8C5EE47C0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9687" y="7228907"/>
            <a:ext cx="2777844" cy="23134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866FE4D-FBA4-0ED9-1CD0-1064B5847E68}"/>
              </a:ext>
            </a:extLst>
          </p:cNvPr>
          <p:cNvSpPr txBox="1"/>
          <p:nvPr/>
        </p:nvSpPr>
        <p:spPr>
          <a:xfrm>
            <a:off x="1448881" y="693174"/>
            <a:ext cx="5218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 source data-DAY 5+SaCas9- 1 to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F45BCF-2207-3F1D-BD7C-4E0CAC74ACB2}"/>
              </a:ext>
            </a:extLst>
          </p:cNvPr>
          <p:cNvSpPr txBox="1"/>
          <p:nvPr/>
        </p:nvSpPr>
        <p:spPr>
          <a:xfrm>
            <a:off x="224684" y="1499612"/>
            <a:ext cx="277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tamin A autofluoresce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2BAB20-DC01-9586-6522-25BA8C05D235}"/>
              </a:ext>
            </a:extLst>
          </p:cNvPr>
          <p:cNvSpPr txBox="1"/>
          <p:nvPr/>
        </p:nvSpPr>
        <p:spPr>
          <a:xfrm>
            <a:off x="4403394" y="1459558"/>
            <a:ext cx="1161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ightfield</a:t>
            </a:r>
          </a:p>
        </p:txBody>
      </p:sp>
    </p:spTree>
    <p:extLst>
      <p:ext uri="{BB962C8B-B14F-4D97-AF65-F5344CB8AC3E}">
        <p14:creationId xmlns:p14="http://schemas.microsoft.com/office/powerpoint/2010/main" val="40631436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745734D-5A9E-8F87-7340-1E49826D72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329" y="2142430"/>
            <a:ext cx="2777844" cy="2309812"/>
          </a:xfrm>
          <a:prstGeom prst="rect">
            <a:avLst/>
          </a:prstGeom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6A60307-BA8A-114C-0824-7F74F25221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329" y="4801087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B0DCED1-AD5B-93A1-0CC4-6FF526A478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8329" y="7478818"/>
            <a:ext cx="2777844" cy="230981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89C93C9-9FE8-3533-20EE-8A4DED5E7E29}"/>
              </a:ext>
            </a:extLst>
          </p:cNvPr>
          <p:cNvPicPr>
            <a:picLocks noChangeAspect="1"/>
          </p:cNvPicPr>
          <p:nvPr/>
        </p:nvPicPr>
        <p:blipFill>
          <a:blip r:embed="rId5">
            <a:lum bright="11000" contrast="21000"/>
          </a:blip>
          <a:stretch>
            <a:fillRect/>
          </a:stretch>
        </p:blipFill>
        <p:spPr>
          <a:xfrm>
            <a:off x="3564152" y="2142430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9D637B8-67C9-6F02-F16F-1A19A2429E6D}"/>
              </a:ext>
            </a:extLst>
          </p:cNvPr>
          <p:cNvPicPr>
            <a:picLocks noChangeAspect="1"/>
          </p:cNvPicPr>
          <p:nvPr/>
        </p:nvPicPr>
        <p:blipFill>
          <a:blip r:embed="rId6">
            <a:lum bright="10000"/>
          </a:blip>
          <a:stretch>
            <a:fillRect/>
          </a:stretch>
        </p:blipFill>
        <p:spPr>
          <a:xfrm>
            <a:off x="3564152" y="4785802"/>
            <a:ext cx="2777844" cy="2313432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80F0F2B-4D8B-2D48-E62B-B7E52E3B94ED}"/>
              </a:ext>
            </a:extLst>
          </p:cNvPr>
          <p:cNvPicPr>
            <a:picLocks noChangeAspect="1"/>
          </p:cNvPicPr>
          <p:nvPr/>
        </p:nvPicPr>
        <p:blipFill>
          <a:blip r:embed="rId7">
            <a:lum bright="11000" contrast="4000"/>
          </a:blip>
          <a:stretch>
            <a:fillRect/>
          </a:stretch>
        </p:blipFill>
        <p:spPr>
          <a:xfrm>
            <a:off x="3564152" y="7482608"/>
            <a:ext cx="2777844" cy="2313432"/>
          </a:xfrm>
          <a:prstGeom prst="rect">
            <a:avLst/>
          </a:prstGeom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ABC50B-1D81-F898-5AD5-F4A0E7D38E34}"/>
              </a:ext>
            </a:extLst>
          </p:cNvPr>
          <p:cNvSpPr txBox="1"/>
          <p:nvPr/>
        </p:nvSpPr>
        <p:spPr>
          <a:xfrm>
            <a:off x="886915" y="599522"/>
            <a:ext cx="4884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D source data-DAY 5+HDR- 1 to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2516DF-5AC5-56F3-292E-7D7ECCD6C7DE}"/>
              </a:ext>
            </a:extLst>
          </p:cNvPr>
          <p:cNvSpPr txBox="1"/>
          <p:nvPr/>
        </p:nvSpPr>
        <p:spPr>
          <a:xfrm>
            <a:off x="224684" y="1499612"/>
            <a:ext cx="2778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tamin A autofluoresce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89F01D2-8BCA-FA18-CA52-FEA1542F409E}"/>
              </a:ext>
            </a:extLst>
          </p:cNvPr>
          <p:cNvSpPr txBox="1"/>
          <p:nvPr/>
        </p:nvSpPr>
        <p:spPr>
          <a:xfrm>
            <a:off x="4403394" y="1459558"/>
            <a:ext cx="1161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ightfield</a:t>
            </a:r>
          </a:p>
        </p:txBody>
      </p:sp>
    </p:spTree>
    <p:extLst>
      <p:ext uri="{BB962C8B-B14F-4D97-AF65-F5344CB8AC3E}">
        <p14:creationId xmlns:p14="http://schemas.microsoft.com/office/powerpoint/2010/main" val="4116322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</TotalTime>
  <Words>52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mal Ramani</dc:creator>
  <cp:lastModifiedBy>Komal Ramani</cp:lastModifiedBy>
  <cp:revision>4</cp:revision>
  <dcterms:created xsi:type="dcterms:W3CDTF">2023-03-30T16:18:11Z</dcterms:created>
  <dcterms:modified xsi:type="dcterms:W3CDTF">2023-04-02T15:24:58Z</dcterms:modified>
</cp:coreProperties>
</file>